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832AF-D445-4455-BB5C-773DDE1FDC90}" type="datetimeFigureOut">
              <a:rPr lang="en-US" smtClean="0"/>
              <a:t>5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DF71E-66E6-4EA4-A965-0E8B7C8047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51664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832AF-D445-4455-BB5C-773DDE1FDC90}" type="datetimeFigureOut">
              <a:rPr lang="en-US" smtClean="0"/>
              <a:t>5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DF71E-66E6-4EA4-A965-0E8B7C8047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0962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832AF-D445-4455-BB5C-773DDE1FDC90}" type="datetimeFigureOut">
              <a:rPr lang="en-US" smtClean="0"/>
              <a:t>5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DF71E-66E6-4EA4-A965-0E8B7C8047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0462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832AF-D445-4455-BB5C-773DDE1FDC90}" type="datetimeFigureOut">
              <a:rPr lang="en-US" smtClean="0"/>
              <a:t>5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DF71E-66E6-4EA4-A965-0E8B7C8047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602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832AF-D445-4455-BB5C-773DDE1FDC90}" type="datetimeFigureOut">
              <a:rPr lang="en-US" smtClean="0"/>
              <a:t>5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DF71E-66E6-4EA4-A965-0E8B7C8047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9074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832AF-D445-4455-BB5C-773DDE1FDC90}" type="datetimeFigureOut">
              <a:rPr lang="en-US" smtClean="0"/>
              <a:t>5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DF71E-66E6-4EA4-A965-0E8B7C8047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67124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832AF-D445-4455-BB5C-773DDE1FDC90}" type="datetimeFigureOut">
              <a:rPr lang="en-US" smtClean="0"/>
              <a:t>5/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DF71E-66E6-4EA4-A965-0E8B7C8047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24188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832AF-D445-4455-BB5C-773DDE1FDC90}" type="datetimeFigureOut">
              <a:rPr lang="en-US" smtClean="0"/>
              <a:t>5/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DF71E-66E6-4EA4-A965-0E8B7C8047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5757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832AF-D445-4455-BB5C-773DDE1FDC90}" type="datetimeFigureOut">
              <a:rPr lang="en-US" smtClean="0"/>
              <a:t>5/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DF71E-66E6-4EA4-A965-0E8B7C8047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716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832AF-D445-4455-BB5C-773DDE1FDC90}" type="datetimeFigureOut">
              <a:rPr lang="en-US" smtClean="0"/>
              <a:t>5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DF71E-66E6-4EA4-A965-0E8B7C8047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89044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832AF-D445-4455-BB5C-773DDE1FDC90}" type="datetimeFigureOut">
              <a:rPr lang="en-US" smtClean="0"/>
              <a:t>5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DF71E-66E6-4EA4-A965-0E8B7C8047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98689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2832AF-D445-4455-BB5C-773DDE1FDC90}" type="datetimeFigureOut">
              <a:rPr lang="en-US" smtClean="0"/>
              <a:t>5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4DF71E-66E6-4EA4-A965-0E8B7C8047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42625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1062" y="374178"/>
            <a:ext cx="8699538" cy="484632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861390" y="5432239"/>
            <a:ext cx="1065474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ea typeface="Calibri" panose="020F0502020204030204" pitchFamily="34" charset="0"/>
              </a:rPr>
              <a:t>S2 Fig.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Allelic frequency of the markers linked to previously mapped stripe rust resistance genes in the spring wheat association mapping panel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6627810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4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bede Muleta</dc:creator>
  <cp:lastModifiedBy>Kebede Muleta</cp:lastModifiedBy>
  <cp:revision>1</cp:revision>
  <dcterms:created xsi:type="dcterms:W3CDTF">2017-05-07T23:19:13Z</dcterms:created>
  <dcterms:modified xsi:type="dcterms:W3CDTF">2017-05-07T23:20:40Z</dcterms:modified>
</cp:coreProperties>
</file>